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3B93E1F-47C7-4988-B6DB-57F6BC7817F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B2C2C91-A44F-4EBD-AB7B-535A1CB875C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EB907A6-FA17-4118-B031-FA7791EA3AD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4D194FC-DE2D-48B4-8C22-692BB50A3497}"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9674492-9F01-4F93-B224-7142795EA1C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D7DCC0C-EE85-44E6-A411-5E8728443E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F23C832-192C-44FD-83EF-83FB27068EA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8E38E48-06FC-4ED3-AD70-D13F4413F5C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B9FF5DA-4CE1-4A85-BC89-31DB1943831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A2800D9-0565-422F-A08A-4BDC1422B4E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ED0963-3D7A-4D2C-97D2-A172E826DDA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588B676-DA42-4F87-9392-9823B3B728D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35480" indent="-28296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3148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58400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36520" indent="-226080">
              <a:spcBef>
                <a:spcPts val="799"/>
              </a:spcBef>
              <a:buClr>
                <a:srgbClr val="000000"/>
              </a:buClr>
              <a:buFont typeface="Times"/>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A190C9C-1961-4615-B35A-C84D92CEA621}" type="slidenum">
              <a:rPr b="0" lang="en-GB"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4683240" y="1219320"/>
            <a:ext cx="3155760" cy="2367000"/>
          </a:xfrm>
          <a:prstGeom prst="rect">
            <a:avLst/>
          </a:prstGeom>
          <a:ln w="9360">
            <a:solidFill>
              <a:srgbClr val="000000"/>
            </a:solidFill>
            <a:miter/>
          </a:ln>
        </p:spPr>
      </p:pic>
      <p:pic>
        <p:nvPicPr>
          <p:cNvPr id="42" name="" descr=""/>
          <p:cNvPicPr/>
          <p:nvPr/>
        </p:nvPicPr>
        <p:blipFill>
          <a:blip r:embed="rId2"/>
          <a:stretch/>
        </p:blipFill>
        <p:spPr>
          <a:xfrm>
            <a:off x="1374840" y="1219320"/>
            <a:ext cx="3155760" cy="2367000"/>
          </a:xfrm>
          <a:prstGeom prst="rect">
            <a:avLst/>
          </a:prstGeom>
          <a:ln w="9360">
            <a:solidFill>
              <a:srgbClr val="000000"/>
            </a:solidFill>
            <a:miter/>
          </a:ln>
        </p:spPr>
      </p:pic>
      <p:sp>
        <p:nvSpPr>
          <p:cNvPr id="43" name=""/>
          <p:cNvSpPr/>
          <p:nvPr/>
        </p:nvSpPr>
        <p:spPr>
          <a:xfrm>
            <a:off x="2626920" y="3622680"/>
            <a:ext cx="764280" cy="434880"/>
          </a:xfrm>
          <a:prstGeom prst="rect">
            <a:avLst/>
          </a:prstGeom>
          <a:noFill/>
          <a:ln w="0">
            <a:noFill/>
          </a:ln>
        </p:spPr>
        <p:style>
          <a:lnRef idx="0"/>
          <a:fillRef idx="0"/>
          <a:effectRef idx="0"/>
          <a:fontRef idx="minor"/>
        </p:style>
        <p:txBody>
          <a:bodyPr wrap="none" lIns="90000" rIns="90000" tIns="46800" bIns="46800" anchor="t">
            <a:spAutoFit/>
          </a:bodyPr>
          <a:p>
            <a:pPr>
              <a:lnSpc>
                <a:spcPct val="16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SW480</a:t>
            </a:r>
            <a:endParaRPr b="0" lang="en-US" sz="1400" spc="-1" strike="noStrike">
              <a:solidFill>
                <a:srgbClr val="000000"/>
              </a:solidFill>
              <a:latin typeface="Times New Roman"/>
            </a:endParaRPr>
          </a:p>
        </p:txBody>
      </p:sp>
      <p:sp>
        <p:nvSpPr>
          <p:cNvPr id="44" name=""/>
          <p:cNvSpPr/>
          <p:nvPr/>
        </p:nvSpPr>
        <p:spPr>
          <a:xfrm>
            <a:off x="5881320" y="3622680"/>
            <a:ext cx="764280" cy="434880"/>
          </a:xfrm>
          <a:prstGeom prst="rect">
            <a:avLst/>
          </a:prstGeom>
          <a:noFill/>
          <a:ln w="0">
            <a:noFill/>
          </a:ln>
        </p:spPr>
        <p:style>
          <a:lnRef idx="0"/>
          <a:fillRef idx="0"/>
          <a:effectRef idx="0"/>
          <a:fontRef idx="minor"/>
        </p:style>
        <p:txBody>
          <a:bodyPr wrap="none" lIns="90000" rIns="90000" tIns="46800" bIns="46800" anchor="t">
            <a:spAutoFit/>
          </a:bodyPr>
          <a:p>
            <a:pPr>
              <a:lnSpc>
                <a:spcPct val="16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rPr>
              <a:t>SW620</a:t>
            </a:r>
            <a:endParaRPr b="0" lang="en-US" sz="1400" spc="-1" strike="noStrike">
              <a:solidFill>
                <a:srgbClr val="000000"/>
              </a:solidFill>
              <a:latin typeface="Times New Roman"/>
            </a:endParaRPr>
          </a:p>
        </p:txBody>
      </p:sp>
      <p:sp>
        <p:nvSpPr>
          <p:cNvPr id="45" name=""/>
          <p:cNvSpPr/>
          <p:nvPr/>
        </p:nvSpPr>
        <p:spPr>
          <a:xfrm>
            <a:off x="1911240" y="4559400"/>
            <a:ext cx="5099040" cy="19191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ＭＳ Ｐゴシック"/>
              </a:rPr>
              <a:t>Additional file 1</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ＭＳ Ｐゴシック"/>
              </a:rPr>
              <a:t>Comparison of SW480 and SW620 CRC cell morphologies</a:t>
            </a:r>
            <a:endParaRPr b="0" lang="en-US" sz="1200" spc="-1" strike="noStrike">
              <a:solidFill>
                <a:srgbClr val="000000"/>
              </a:solidFill>
              <a:latin typeface="Times New Roman"/>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ＭＳ Ｐゴシック"/>
              </a:rPr>
              <a:t>Cells are grown on cell culture plastic without extra coating. Both images were taken ca. 60 h after cell passaging and are shown at the same magnification. The SW480 cells, which are derived from primary tumor tissue appear more attached. SW620 cells, derived from a lymph node metastasis of the same patient appear to be on average smaller and more spindle shaped. Similar morphological changes are, for example, also observed with fibroblasts upon transformation by SFK.</a:t>
            </a:r>
            <a:endParaRPr b="0" lang="en-US" sz="12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17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05-29T18:45:42Z</dcterms:created>
  <dc:creator>admin</dc:creator>
  <dc:description/>
  <dc:language>en-US</dc:language>
  <cp:lastModifiedBy>daniel.darriba</cp:lastModifiedBy>
  <cp:lastPrinted>2008-09-22T17:07:37Z</cp:lastPrinted>
  <dcterms:modified xsi:type="dcterms:W3CDTF">2008-11-03T11:35:13Z</dcterms:modified>
  <cp:revision>94</cp:revision>
  <dc:subject/>
  <dc:title>PowerPoint Presentation</dc:title>
</cp:coreProperties>
</file>